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4CC65-81F4-4879-BDCF-5D2152BC6C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B31E3-2AC3-437E-B448-49BCC30002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A3DDBC-5665-4967-9786-F0E1EB3F03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FDE23-E43F-49B6-A82D-D07A98C26D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02E5A-206E-447C-BAB1-4DF4136EFB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887DA2-995A-48D4-A9B8-84F1FB0150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8A7F6-D934-4E65-8F8D-8BD2075C61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62558-4375-46CF-8A42-1C68340D07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C93B7-5113-42FA-A067-0F9F91B534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70C21-22C4-4A30-AC73-CF9CCC87C5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4048B-4CCA-4563-9E0B-7113E20AC2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127584-58F9-4BC8-A804-4E50FB100D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AFF07B-FB13-459F-AF34-604E9ED4F884}" type="slidenum"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62840" y="608760"/>
            <a:ext cx="5257080" cy="3483360"/>
            <a:chOff x="762840" y="608760"/>
            <a:chExt cx="5257080" cy="3483360"/>
          </a:xfrm>
        </p:grpSpPr>
        <p:sp>
          <p:nvSpPr>
            <p:cNvPr id="42" name=""/>
            <p:cNvSpPr/>
            <p:nvPr/>
          </p:nvSpPr>
          <p:spPr>
            <a:xfrm>
              <a:off x="804960" y="611280"/>
              <a:ext cx="1839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762840" y="608760"/>
              <a:ext cx="1424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Anastrepha obliqu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763200" y="2044080"/>
              <a:ext cx="125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Ceratitis capitat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762840" y="3351960"/>
              <a:ext cx="177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Drosophila melanogaster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6" name=""/>
            <p:cNvGrpSpPr/>
            <p:nvPr/>
          </p:nvGrpSpPr>
          <p:grpSpPr>
            <a:xfrm>
              <a:off x="806400" y="914400"/>
              <a:ext cx="5213520" cy="458640"/>
              <a:chOff x="806400" y="914400"/>
              <a:chExt cx="5213520" cy="458640"/>
            </a:xfrm>
          </p:grpSpPr>
          <p:sp>
            <p:nvSpPr>
              <p:cNvPr id="47" name=""/>
              <p:cNvSpPr/>
              <p:nvPr/>
            </p:nvSpPr>
            <p:spPr>
              <a:xfrm>
                <a:off x="819360" y="1187280"/>
                <a:ext cx="5181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806400" y="1079280"/>
                <a:ext cx="36216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486080" y="1079280"/>
                <a:ext cx="36180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2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190960" y="1079280"/>
                <a:ext cx="36180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3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876760" y="1079280"/>
                <a:ext cx="36180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4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562560" y="1079280"/>
                <a:ext cx="36180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5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267440" y="1079280"/>
                <a:ext cx="36180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6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953240" y="1079280"/>
                <a:ext cx="36180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7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5645160" y="1079280"/>
                <a:ext cx="362160" cy="24300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8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81936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30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49868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8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20356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26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88936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7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57516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2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428004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76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96584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4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5658120" y="9144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885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143000" y="1130040"/>
                <a:ext cx="36216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29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822680" y="1130040"/>
                <a:ext cx="36180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7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552760" y="1130040"/>
                <a:ext cx="36216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87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3232080" y="1130040"/>
                <a:ext cx="36216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67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3930840" y="1130040"/>
                <a:ext cx="36180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26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616640" y="1130040"/>
                <a:ext cx="36180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6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5315040" y="1130040"/>
                <a:ext cx="361800" cy="243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65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71" name=""/>
            <p:cNvGrpSpPr/>
            <p:nvPr/>
          </p:nvGrpSpPr>
          <p:grpSpPr>
            <a:xfrm>
              <a:off x="806400" y="2286000"/>
              <a:ext cx="5213520" cy="458280"/>
              <a:chOff x="806400" y="2286000"/>
              <a:chExt cx="5213520" cy="458280"/>
            </a:xfrm>
          </p:grpSpPr>
          <p:sp>
            <p:nvSpPr>
              <p:cNvPr id="72" name=""/>
              <p:cNvSpPr/>
              <p:nvPr/>
            </p:nvSpPr>
            <p:spPr>
              <a:xfrm>
                <a:off x="819000" y="2565000"/>
                <a:ext cx="518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806400" y="245736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486080" y="2457360"/>
                <a:ext cx="36180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190600" y="245736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876400" y="245736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3562200" y="245736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5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4267080" y="245736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6a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952880" y="245736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6b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645160" y="2457360"/>
                <a:ext cx="36180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7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819000" y="228600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86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498680" y="22860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8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203560" y="22860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2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889360" y="22860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7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3575160" y="22860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2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280040" y="22860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76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4965840" y="228600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4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5657760" y="228600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22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143000" y="25016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31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1841400" y="250164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6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546280" y="250164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83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3219480" y="25016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7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3930480" y="250164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279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610160" y="25016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7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315040" y="25016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7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96" name=""/>
            <p:cNvGrpSpPr/>
            <p:nvPr/>
          </p:nvGrpSpPr>
          <p:grpSpPr>
            <a:xfrm>
              <a:off x="806400" y="3633840"/>
              <a:ext cx="4521240" cy="458280"/>
              <a:chOff x="806400" y="3633840"/>
              <a:chExt cx="4521240" cy="458280"/>
            </a:xfrm>
          </p:grpSpPr>
          <p:sp>
            <p:nvSpPr>
              <p:cNvPr id="97" name=""/>
              <p:cNvSpPr/>
              <p:nvPr/>
            </p:nvSpPr>
            <p:spPr>
              <a:xfrm>
                <a:off x="819000" y="3912840"/>
                <a:ext cx="4419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806400" y="3805200"/>
                <a:ext cx="36180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485720" y="380520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190600" y="380520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876400" y="380520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562200" y="380520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5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267080" y="380520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6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952880" y="3805200"/>
                <a:ext cx="362160" cy="2422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eeeeee"/>
                  </a:gs>
                  <a:gs pos="100000">
                    <a:srgbClr val="000000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e7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819000" y="363384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56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1498680" y="36338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4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203560" y="36338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8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889360" y="36338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15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575160" y="36338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66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280040" y="36338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37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965840" y="363384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46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1143000" y="3849480"/>
                <a:ext cx="36180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7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1822320" y="384948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5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546280" y="384948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23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232080" y="384948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58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930480" y="384948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347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616280" y="3849480"/>
                <a:ext cx="362160" cy="24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omic Sans MS"/>
                    <a:ea typeface="ＭＳ Ｐゴシック"/>
                  </a:rPr>
                  <a:t>6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18" name=""/>
          <p:cNvSpPr/>
          <p:nvPr/>
        </p:nvSpPr>
        <p:spPr>
          <a:xfrm>
            <a:off x="3038400" y="533412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26T10:18:30Z</dcterms:created>
  <dc:creator>BEGOÑA</dc:creator>
  <dc:description/>
  <dc:language>en-US</dc:language>
  <cp:lastModifiedBy>Lucas Sánchez Rodríguez</cp:lastModifiedBy>
  <cp:lastPrinted>2010-04-09T11:20:15Z</cp:lastPrinted>
  <dcterms:modified xsi:type="dcterms:W3CDTF">2010-05-03T10:50:28Z</dcterms:modified>
  <cp:revision>60</cp:revision>
  <dc:subject/>
  <dc:title>Sin título de diapositiva</dc:title>
</cp:coreProperties>
</file>